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8" autoAdjust="0"/>
    <p:restoredTop sz="94660"/>
  </p:normalViewPr>
  <p:slideViewPr>
    <p:cSldViewPr snapToGrid="0">
      <p:cViewPr varScale="1">
        <p:scale>
          <a:sx n="77" d="100"/>
          <a:sy n="77" d="100"/>
        </p:scale>
        <p:origin x="129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7248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31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123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743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890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114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650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409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46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673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715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317F4-30D5-4FAA-A47A-3791760169F7}" type="datetimeFigureOut">
              <a:rPr lang="en-US" smtClean="0"/>
              <a:t>1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4115DB-9A97-410F-82D5-5AE8F52E6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075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61DD0770-05B5-44C1-9BCA-D9D75CF4D795}"/>
              </a:ext>
            </a:extLst>
          </p:cNvPr>
          <p:cNvGrpSpPr/>
          <p:nvPr/>
        </p:nvGrpSpPr>
        <p:grpSpPr>
          <a:xfrm>
            <a:off x="-323700" y="1169362"/>
            <a:ext cx="6708662" cy="4325121"/>
            <a:chOff x="74669" y="2409439"/>
            <a:chExt cx="6708662" cy="4325121"/>
          </a:xfrm>
        </p:grpSpPr>
        <p:pic>
          <p:nvPicPr>
            <p:cNvPr id="7" name="Picture 6" descr="A close-up of a plant&#10;&#10;Description automatically generated with medium confidence">
              <a:extLst>
                <a:ext uri="{FF2B5EF4-FFF2-40B4-BE49-F238E27FC236}">
                  <a16:creationId xmlns:a16="http://schemas.microsoft.com/office/drawing/2014/main" id="{1A262FDE-7AF6-4F10-95FA-282CC96A027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669" y="2409439"/>
              <a:ext cx="6708662" cy="4325121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FBDE593E-0823-4A87-833F-A52ED32EC0CA}"/>
                </a:ext>
              </a:extLst>
            </p:cNvPr>
            <p:cNvGrpSpPr/>
            <p:nvPr/>
          </p:nvGrpSpPr>
          <p:grpSpPr>
            <a:xfrm>
              <a:off x="1528176" y="3243720"/>
              <a:ext cx="3639332" cy="3401860"/>
              <a:chOff x="1528176" y="3243720"/>
              <a:chExt cx="3639332" cy="3401860"/>
            </a:xfrm>
          </p:grpSpPr>
          <p:sp>
            <p:nvSpPr>
              <p:cNvPr id="8" name="Arrow: Right 7">
                <a:extLst>
                  <a:ext uri="{FF2B5EF4-FFF2-40B4-BE49-F238E27FC236}">
                    <a16:creationId xmlns:a16="http://schemas.microsoft.com/office/drawing/2014/main" id="{2335622D-E879-47F4-B5DE-258517232D25}"/>
                  </a:ext>
                </a:extLst>
              </p:cNvPr>
              <p:cNvSpPr/>
              <p:nvPr/>
            </p:nvSpPr>
            <p:spPr>
              <a:xfrm>
                <a:off x="1528176" y="3782861"/>
                <a:ext cx="457200" cy="2286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Arrow: Right 8">
                <a:extLst>
                  <a:ext uri="{FF2B5EF4-FFF2-40B4-BE49-F238E27FC236}">
                    <a16:creationId xmlns:a16="http://schemas.microsoft.com/office/drawing/2014/main" id="{EC11D312-D4DC-4CA0-A2C0-B159A5673A78}"/>
                  </a:ext>
                </a:extLst>
              </p:cNvPr>
              <p:cNvSpPr/>
              <p:nvPr/>
            </p:nvSpPr>
            <p:spPr>
              <a:xfrm rot="15304429">
                <a:off x="4824608" y="6302680"/>
                <a:ext cx="457200" cy="2286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Arrow: Right 9">
                <a:extLst>
                  <a:ext uri="{FF2B5EF4-FFF2-40B4-BE49-F238E27FC236}">
                    <a16:creationId xmlns:a16="http://schemas.microsoft.com/office/drawing/2014/main" id="{EC3E0641-C725-4B37-A6D4-2C31CC953D9E}"/>
                  </a:ext>
                </a:extLst>
              </p:cNvPr>
              <p:cNvSpPr/>
              <p:nvPr/>
            </p:nvSpPr>
            <p:spPr>
              <a:xfrm rot="16762301">
                <a:off x="3336099" y="6111658"/>
                <a:ext cx="457200" cy="2286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Arrow: Right 10">
                <a:extLst>
                  <a:ext uri="{FF2B5EF4-FFF2-40B4-BE49-F238E27FC236}">
                    <a16:creationId xmlns:a16="http://schemas.microsoft.com/office/drawing/2014/main" id="{C1CEA052-7996-4564-B8F8-02A9B790E7D7}"/>
                  </a:ext>
                </a:extLst>
              </p:cNvPr>
              <p:cNvSpPr/>
              <p:nvPr/>
            </p:nvSpPr>
            <p:spPr>
              <a:xfrm rot="6531193">
                <a:off x="3793299" y="3358020"/>
                <a:ext cx="457200" cy="228600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A2BD907F-502A-4EC1-8883-979CC47ECE84}"/>
              </a:ext>
            </a:extLst>
          </p:cNvPr>
          <p:cNvSpPr txBox="1"/>
          <p:nvPr/>
        </p:nvSpPr>
        <p:spPr>
          <a:xfrm>
            <a:off x="590777" y="6431424"/>
            <a:ext cx="579850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S12 |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redicted structure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-Als3 (green)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cerevisia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1 (gold) align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M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dues and resulting disulfide bonds are shown in purple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-Als3 and orange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cerevisia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1. Black arrows indicate positions where disulfide bonds are found in each structure. The red arrow indicates a disulfide bond that is present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-Als3, but not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cerevisia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1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62081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8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is Hoyer</dc:creator>
  <cp:lastModifiedBy>Lois Hoyer</cp:lastModifiedBy>
  <cp:revision>2</cp:revision>
  <dcterms:created xsi:type="dcterms:W3CDTF">2021-11-08T16:58:11Z</dcterms:created>
  <dcterms:modified xsi:type="dcterms:W3CDTF">2021-11-08T17:15:10Z</dcterms:modified>
</cp:coreProperties>
</file>